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3" d="100"/>
          <a:sy n="53" d="100"/>
        </p:scale>
        <p:origin x="114" y="18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BA419A-7CB0-4E49-B71E-4113528B32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5F6B91A-B69D-4354-8AEB-69F3BC787A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E9AD6FC-FB43-4EA6-B747-F422E458B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C9DA670-49E5-4E3D-9001-87ABFEE381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1A46B8-FD8D-4C11-9E8B-BB2A0053A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5759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37BD87-FCE1-40C6-B8C6-F2818FBB3D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09556A7-08DF-4574-A84C-BA5F9BA6DE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B3793B-3D3F-492B-8705-0BDD32F4F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C8349E-61D0-4257-A948-E7DC1D628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8FF851-FEB3-46AD-9F19-ADCA0E0C1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2218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58A16EB-7A86-48FA-B5CC-D55CB4E775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EE5F77C-D98E-45A0-BE17-770E36D369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50384F-3205-464F-BAC5-D095F1354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522237-E480-4279-A405-5B131E8A5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51C722-5E8F-445F-8BED-23729E0A1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87310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26FF02-53B4-4B6C-8143-FE519738D6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F273221-5BE7-439E-959B-59F97CC92F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6A154B-9DC0-4AD8-82FC-1079147B1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95B88F-5932-440C-8DD5-AB83D5B92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89D645-6E1B-4186-8E96-D1CBB3289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9733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C263F4-8635-4FA1-8D86-8585BC79B3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95E26B1-753D-4DBF-9807-116C342CC7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51DCFB-F37F-4E51-B293-48508C786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9CDA8D-E6E6-4EDF-8860-42B1C59CC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B006BC-D3AF-45CC-A7C6-BF063E245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5435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8D35E9-8F96-457B-817E-D4A73E141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080A2F7-4C5B-43FA-905F-0DB17D57E9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DA5EA38-26F7-48D5-859C-0B5A2C3AB6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C19D791-338F-481A-82DA-8312F4EA2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AAFEDE-AA1D-40DD-B8B1-5A7E1CA03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8149E69-8660-4286-9795-0FAE25066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0173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9BDD5D-F9AB-4B91-9F44-3E03F0676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3DF4BFE-7D16-46FC-AF58-3408C18D04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54EC500-35F5-47D1-99A0-49CA5378D0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06D95EB-3F1F-4B2B-8941-87BBBACEC2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5CC41DA-C098-4493-80D8-1B25C12931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8C2E657-9CB9-478D-BD71-9DF5250F1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D616C8F-4068-41E9-B036-3A90E3ACD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C26E7F3-F328-449D-B8CE-F59895412E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496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0D1A98-C1C5-45F6-A8C7-91BB828F71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FE38A67-35B7-414E-8D58-282D95CFA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E468D70-801F-4A36-A6AF-9586C4992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9CA6133-0580-47AF-B893-1C86B1D925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5952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E3AAD2C-87BA-4D66-B521-09BE5D21D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DF42E4F-FEB2-439B-A977-52D7AB7F3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2830A1E-36FF-438B-B538-EB3368013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5400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78B282-2E56-4DC1-B309-281199818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CE414A8-4492-4335-8D24-C4BAF3E616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071949E-A166-4922-A569-92009FB52F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01665F4-50EB-4D26-8A2E-55EB2EFAA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12683E-7ECC-44F6-BFCB-6B9381F7D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B797BD-F204-4A53-BB46-2AE4C9ECA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12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3A379F-EEE7-4E51-980A-F3B46C13CE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9C87F9C-1AD9-447B-8D83-38BFED202E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8423DE9-B64D-4492-8E39-526D7C78D9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D7DD50C-89AB-4059-B57B-4272B3D59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DEACB6-59F3-4C86-90D2-0CDA774C2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6F2A508-BF20-40E4-A402-774373ACD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385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897BD5F-C89E-4791-91E2-079FF328A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CDE953F-1EFA-4F0F-B8E7-8C20736877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81CF8C2-177F-4B77-B4AB-69A14D7A44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7FC13-5ADD-42B9-85CB-D5571599B263}" type="datetimeFigureOut">
              <a:rPr lang="zh-CN" altLang="en-US" smtClean="0"/>
              <a:t>2025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4128B3-8E7C-4D11-A498-C7F6A606DC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DBDA1B-9617-4263-89A9-4BB8591341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F0AF2-20A4-489D-B7EA-6458E596B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994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345A761-3EDC-4FE1-9AB2-D6B9B817F6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0944" y="1414005"/>
            <a:ext cx="8236410" cy="308484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257A2CC-CE8D-4FA0-AB83-8299B8976C9B}"/>
              </a:ext>
            </a:extLst>
          </p:cNvPr>
          <p:cNvSpPr txBox="1"/>
          <p:nvPr/>
        </p:nvSpPr>
        <p:spPr>
          <a:xfrm>
            <a:off x="491113" y="4517136"/>
            <a:ext cx="112097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1. Immunomodulatory and Antioxidant Functions of Parent Peptides (a) Stimulation activity of parent peptides on RAW-Lucia NF-</a:t>
            </a:r>
            <a:r>
              <a:rPr lang="el-GR" altLang="zh-CN" dirty="0"/>
              <a:t>κ</a:t>
            </a:r>
            <a:r>
              <a:rPr lang="en-US" altLang="zh-CN" dirty="0"/>
              <a:t>B cells. **P</a:t>
            </a:r>
            <a:r>
              <a:rPr lang="zh-CN" altLang="zh-CN" dirty="0"/>
              <a:t> ≤</a:t>
            </a:r>
            <a:r>
              <a:rPr lang="en-US" altLang="zh-CN" dirty="0"/>
              <a:t> 0.01,  ***P </a:t>
            </a:r>
            <a:r>
              <a:rPr lang="zh-CN" altLang="zh-CN" dirty="0"/>
              <a:t>≤</a:t>
            </a:r>
            <a:r>
              <a:rPr lang="en-US" altLang="zh-CN" dirty="0"/>
              <a:t> 0.001, ****P </a:t>
            </a:r>
            <a:r>
              <a:rPr lang="zh-CN" altLang="zh-CN" dirty="0"/>
              <a:t>≤</a:t>
            </a:r>
            <a:r>
              <a:rPr lang="en-US" altLang="zh-CN" dirty="0"/>
              <a:t> 0.0001, compared to the CON group.(b) Stimulation activity of parent peptides on IPEC-J2-Lucia ARE cells. **P</a:t>
            </a:r>
            <a:r>
              <a:rPr lang="zh-CN" altLang="zh-CN" dirty="0"/>
              <a:t> ≤</a:t>
            </a:r>
            <a:r>
              <a:rPr lang="en-US" altLang="zh-CN" dirty="0"/>
              <a:t> 0.01,  ***P </a:t>
            </a:r>
            <a:r>
              <a:rPr lang="zh-CN" altLang="zh-CN" dirty="0"/>
              <a:t>≤</a:t>
            </a:r>
            <a:r>
              <a:rPr lang="en-US" altLang="zh-CN" dirty="0"/>
              <a:t> 0.001, ****P </a:t>
            </a:r>
            <a:r>
              <a:rPr lang="zh-CN" altLang="zh-CN" dirty="0"/>
              <a:t>≤</a:t>
            </a:r>
            <a:r>
              <a:rPr lang="en-US" altLang="zh-CN" dirty="0"/>
              <a:t> 0.0001, compared to the CON group. 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7D8144D-5544-4DDC-96B4-9F797A6CB188}"/>
              </a:ext>
            </a:extLst>
          </p:cNvPr>
          <p:cNvSpPr txBox="1"/>
          <p:nvPr/>
        </p:nvSpPr>
        <p:spPr>
          <a:xfrm>
            <a:off x="517712" y="322729"/>
            <a:ext cx="1106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23949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1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unyong Wang</dc:creator>
  <cp:lastModifiedBy>Junyong Wang</cp:lastModifiedBy>
  <cp:revision>2</cp:revision>
  <dcterms:created xsi:type="dcterms:W3CDTF">2025-01-07T06:14:05Z</dcterms:created>
  <dcterms:modified xsi:type="dcterms:W3CDTF">2025-01-07T06:15:49Z</dcterms:modified>
</cp:coreProperties>
</file>